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572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B141CDC-8EDC-4C03-AAE2-DD88645A62F6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9D8A79-B35B-4DF6-833F-ED7C9DD4C2E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66317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 err="1"/>
              <a:t>Platelets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09D8A79-B35B-4DF6-833F-ED7C9DD4C2E9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48916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C186103-E907-E2B7-C8DD-ED5D4DE0D0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9BEAFEB2-B0A8-4572-F57C-B57922EB4C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6616BFA-60FA-8C00-7A44-E04F21FA27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B304-EB4D-4457-8666-8930E4FA0140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896DE14-A45A-9955-662D-18A81BE501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2E6CF9B-899F-056B-26E3-4E4883EEE1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3E0A-7433-489C-9294-83EA8B235D6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043253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3F6BD13-DC24-9F71-31C5-D14618BA7E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3F0306D4-43EE-3328-C897-82A119E8FE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2455C9F-F79E-8F1C-70A8-323454EC71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B304-EB4D-4457-8666-8930E4FA0140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90D6AB1-8A04-D592-5274-F7B047D8C9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AA8137B-5839-D806-36CE-7B7248BB83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3E0A-7433-489C-9294-83EA8B235D6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29304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1B59B5D5-384C-973C-3872-591C4508112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24F2E6F-32BA-49B3-A702-48328B4E4F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7D674D6-F533-9712-EF52-FFA471DC0A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B304-EB4D-4457-8666-8930E4FA0140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DE4A4B1-AEF7-C565-C98B-150C34CE7B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ECED002-6218-A227-A4C4-B74805C036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3E0A-7433-489C-9294-83EA8B235D6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97700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0143415-770D-DA38-7EE7-B767BAC321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44F4D23-29A9-62ED-C48D-F9BB7ECADC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DE8F67B-E3FA-0272-23A7-8FD7067D13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B304-EB4D-4457-8666-8930E4FA0140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F3D7662-2964-CE3D-D9E1-FDC9B4CE96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10AA0B5-6F31-A4B2-FBCC-D4E8D6AE4D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3E0A-7433-489C-9294-83EA8B235D6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24830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30994CB-7A0E-929D-68E7-85FD6BFDFE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3862926-5E99-EB73-1C65-6AC58CF517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71D1EE8-A75D-F32F-9D79-9CD653A97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B304-EB4D-4457-8666-8930E4FA0140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BFBB921-05EE-1AC2-BB96-6D17E63C29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FF6F239-6353-856E-9BF0-8DF4FC0C26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3E0A-7433-489C-9294-83EA8B235D6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7798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832AD68-1683-4A22-F4ED-FA1D243C94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735B394-21BC-13DA-08EC-9E520D33D14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A236AD0D-1566-6FF1-AB6F-5F253B61AD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553B34A-7426-D2E6-0467-8DFD7024F5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B304-EB4D-4457-8666-8930E4FA0140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373BB2A-63B2-AB5F-FBD9-A00626AA1B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DDCCCF1-F719-2EC2-C2BD-6F57FD1594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3E0A-7433-489C-9294-83EA8B235D6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67138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232CC35-1D6F-E8C5-1DFE-CD7E8F4D89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4D87C7E-0FE2-5886-B4FD-F24ABDC653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192845C-268C-FEFE-A85D-98020787D9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508439A1-1CE0-E110-5F38-7D4A8F297A1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6E634F75-8E27-033B-22C1-62D5BF4D8C4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BD1E6798-D540-1871-07EF-51F94E949C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B304-EB4D-4457-8666-8930E4FA0140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B65B44A2-450A-3231-CEDA-8E7EA598DA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EC1376EC-16E1-54E4-DCD6-4034FC9E15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3E0A-7433-489C-9294-83EA8B235D6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55999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DB4E0AC-334E-764E-CAB0-BA9EA8E5E9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96B271B4-4088-7078-E96D-31DFE302CE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B304-EB4D-4457-8666-8930E4FA0140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44B7565D-EA06-D02D-5DAB-334C2B7A59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ABCBA51F-24C5-6F50-2DE2-26741076B5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3E0A-7433-489C-9294-83EA8B235D6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492488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159FC86D-85B4-C4CC-4952-9A0CA3E90E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B304-EB4D-4457-8666-8930E4FA0140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A9DC3A47-F1C4-C753-34C0-A281991F83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8825B4CF-73BC-2122-E62D-C3F16E058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3E0A-7433-489C-9294-83EA8B235D6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25867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A88B686-A63E-7921-4496-6625E7699F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1326F99-5911-B1B3-D5DF-4CAA96F2FBA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246F26AD-3E3B-ACE7-4405-D81A25A0FA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56C0932-6227-6C95-BD02-C75D27AECF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B304-EB4D-4457-8666-8930E4FA0140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7C067F8C-5E2C-2340-87CF-205E0512F9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06332AF-6794-DC3B-E91A-F969DAF880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3E0A-7433-489C-9294-83EA8B235D6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5821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2446FF6-DB8D-7271-9158-FDCCB2E4B7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A2683BC0-7DE3-72F5-B856-62815A3D56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0F1E2F1C-3586-583C-051F-FFD7736E57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4D8B45D-6D32-F0E1-BF6F-D744D9E31A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B304-EB4D-4457-8666-8930E4FA0140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EBD33CA-748E-FD71-3293-CFC113464C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A7D15BA-7958-4195-1AD1-12221EBD7B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3E0A-7433-489C-9294-83EA8B235D6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936774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5DD9101F-E14D-4A59-2ABE-9A80E6999C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9C2218A-2095-AE10-8942-BAEE4722B4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A3BDBAE-857B-EE47-BB8C-99FE79A592D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385B304-EB4D-4457-8666-8930E4FA0140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748B543-E39D-E194-7CA6-14F1B98869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3F8A81A-6064-D1E8-6C99-92AB319F30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FF13E0A-7433-489C-9294-83EA8B235D6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45661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4BB016F9-29F7-EF66-624E-51702630D64A}"/>
              </a:ext>
            </a:extLst>
          </p:cNvPr>
          <p:cNvSpPr txBox="1"/>
          <p:nvPr/>
        </p:nvSpPr>
        <p:spPr>
          <a:xfrm>
            <a:off x="4142779" y="581025"/>
            <a:ext cx="3962996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600" b="1">
                <a:latin typeface="Symbol" panose="05050102010706020507" pitchFamily="18" charset="2"/>
              </a:rPr>
              <a:t>D</a:t>
            </a:r>
            <a:r>
              <a:rPr lang="de-DE" sz="1600" b="1">
                <a:latin typeface="Arial" panose="020B0604020202020204" pitchFamily="34" charset="0"/>
                <a:cs typeface="Arial" panose="020B0604020202020204" pitchFamily="34" charset="0"/>
              </a:rPr>
              <a:t>Ct, </a:t>
            </a:r>
            <a:r>
              <a:rPr lang="de-DE" sz="1600" b="1">
                <a:latin typeface="Symbol" panose="05050102010706020507" pitchFamily="18" charset="2"/>
              </a:rPr>
              <a:t>DD</a:t>
            </a:r>
            <a:r>
              <a:rPr lang="de-DE" sz="1600" b="1">
                <a:latin typeface="Arial" panose="020B0604020202020204" pitchFamily="34" charset="0"/>
                <a:cs typeface="Arial" panose="020B0604020202020204" pitchFamily="34" charset="0"/>
              </a:rPr>
              <a:t>Ct, 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platelets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34065E66-BE19-84BF-75C7-FA8A0421EDE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54217307"/>
              </p:ext>
            </p:extLst>
          </p:nvPr>
        </p:nvGraphicFramePr>
        <p:xfrm>
          <a:off x="409575" y="1166318"/>
          <a:ext cx="11439526" cy="44876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17109">
                  <a:extLst>
                    <a:ext uri="{9D8B030D-6E8A-4147-A177-3AD203B41FA5}">
                      <a16:colId xmlns:a16="http://schemas.microsoft.com/office/drawing/2014/main" val="710621134"/>
                    </a:ext>
                  </a:extLst>
                </a:gridCol>
                <a:gridCol w="817109">
                  <a:extLst>
                    <a:ext uri="{9D8B030D-6E8A-4147-A177-3AD203B41FA5}">
                      <a16:colId xmlns:a16="http://schemas.microsoft.com/office/drawing/2014/main" val="2516458380"/>
                    </a:ext>
                  </a:extLst>
                </a:gridCol>
                <a:gridCol w="817109">
                  <a:extLst>
                    <a:ext uri="{9D8B030D-6E8A-4147-A177-3AD203B41FA5}">
                      <a16:colId xmlns:a16="http://schemas.microsoft.com/office/drawing/2014/main" val="759925137"/>
                    </a:ext>
                  </a:extLst>
                </a:gridCol>
                <a:gridCol w="817109">
                  <a:extLst>
                    <a:ext uri="{9D8B030D-6E8A-4147-A177-3AD203B41FA5}">
                      <a16:colId xmlns:a16="http://schemas.microsoft.com/office/drawing/2014/main" val="2669741913"/>
                    </a:ext>
                  </a:extLst>
                </a:gridCol>
                <a:gridCol w="817109">
                  <a:extLst>
                    <a:ext uri="{9D8B030D-6E8A-4147-A177-3AD203B41FA5}">
                      <a16:colId xmlns:a16="http://schemas.microsoft.com/office/drawing/2014/main" val="3758866566"/>
                    </a:ext>
                  </a:extLst>
                </a:gridCol>
                <a:gridCol w="817109">
                  <a:extLst>
                    <a:ext uri="{9D8B030D-6E8A-4147-A177-3AD203B41FA5}">
                      <a16:colId xmlns:a16="http://schemas.microsoft.com/office/drawing/2014/main" val="4013023565"/>
                    </a:ext>
                  </a:extLst>
                </a:gridCol>
                <a:gridCol w="817109">
                  <a:extLst>
                    <a:ext uri="{9D8B030D-6E8A-4147-A177-3AD203B41FA5}">
                      <a16:colId xmlns:a16="http://schemas.microsoft.com/office/drawing/2014/main" val="353101868"/>
                    </a:ext>
                  </a:extLst>
                </a:gridCol>
                <a:gridCol w="817109">
                  <a:extLst>
                    <a:ext uri="{9D8B030D-6E8A-4147-A177-3AD203B41FA5}">
                      <a16:colId xmlns:a16="http://schemas.microsoft.com/office/drawing/2014/main" val="2262448776"/>
                    </a:ext>
                  </a:extLst>
                </a:gridCol>
                <a:gridCol w="817109">
                  <a:extLst>
                    <a:ext uri="{9D8B030D-6E8A-4147-A177-3AD203B41FA5}">
                      <a16:colId xmlns:a16="http://schemas.microsoft.com/office/drawing/2014/main" val="1219302334"/>
                    </a:ext>
                  </a:extLst>
                </a:gridCol>
                <a:gridCol w="817109">
                  <a:extLst>
                    <a:ext uri="{9D8B030D-6E8A-4147-A177-3AD203B41FA5}">
                      <a16:colId xmlns:a16="http://schemas.microsoft.com/office/drawing/2014/main" val="2200978938"/>
                    </a:ext>
                  </a:extLst>
                </a:gridCol>
                <a:gridCol w="817109">
                  <a:extLst>
                    <a:ext uri="{9D8B030D-6E8A-4147-A177-3AD203B41FA5}">
                      <a16:colId xmlns:a16="http://schemas.microsoft.com/office/drawing/2014/main" val="3914359585"/>
                    </a:ext>
                  </a:extLst>
                </a:gridCol>
                <a:gridCol w="817109">
                  <a:extLst>
                    <a:ext uri="{9D8B030D-6E8A-4147-A177-3AD203B41FA5}">
                      <a16:colId xmlns:a16="http://schemas.microsoft.com/office/drawing/2014/main" val="4170691161"/>
                    </a:ext>
                  </a:extLst>
                </a:gridCol>
                <a:gridCol w="817109">
                  <a:extLst>
                    <a:ext uri="{9D8B030D-6E8A-4147-A177-3AD203B41FA5}">
                      <a16:colId xmlns:a16="http://schemas.microsoft.com/office/drawing/2014/main" val="4015710644"/>
                    </a:ext>
                  </a:extLst>
                </a:gridCol>
                <a:gridCol w="817109">
                  <a:extLst>
                    <a:ext uri="{9D8B030D-6E8A-4147-A177-3AD203B41FA5}">
                      <a16:colId xmlns:a16="http://schemas.microsoft.com/office/drawing/2014/main" val="3210544960"/>
                    </a:ext>
                  </a:extLst>
                </a:gridCol>
              </a:tblGrid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Proband/Pat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Tumor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miR-138</a:t>
                      </a:r>
                      <a:r>
                        <a:rPr lang="de-DE" sz="1000" b="1" u="none" strike="noStrike"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de-DE" sz="1000" b="1" u="none" strike="noStrike">
                          <a:effectLst/>
                        </a:rPr>
                        <a:t>Ct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miR-181</a:t>
                      </a:r>
                      <a:r>
                        <a:rPr lang="de-DE" sz="1000" b="1" u="none" strike="noStrike"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de-DE" sz="1000" b="1" u="none" strike="noStrike">
                          <a:effectLst/>
                        </a:rPr>
                        <a:t>Ct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miR-143</a:t>
                      </a:r>
                      <a:r>
                        <a:rPr lang="de-DE" sz="1000" b="1" u="none" strike="noStrike"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de-DE" sz="1000" b="1" u="none" strike="noStrike">
                          <a:effectLst/>
                        </a:rPr>
                        <a:t>Ct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miR-145</a:t>
                      </a:r>
                      <a:r>
                        <a:rPr lang="de-DE" sz="1000" b="1" u="none" strike="noStrike"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de-DE" sz="1000" b="1" u="none" strike="noStrike">
                          <a:effectLst/>
                        </a:rPr>
                        <a:t>Ct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miR-138</a:t>
                      </a:r>
                      <a:r>
                        <a:rPr lang="de-DE" sz="1000" b="1" u="none" strike="noStrike">
                          <a:effectLst/>
                          <a:latin typeface="Symbol" panose="05050102010706020507" pitchFamily="18" charset="2"/>
                        </a:rPr>
                        <a:t>DD</a:t>
                      </a:r>
                      <a:r>
                        <a:rPr lang="de-DE" sz="1000" b="1" u="none" strike="noStrike">
                          <a:effectLst/>
                        </a:rPr>
                        <a:t>Ct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miR-181</a:t>
                      </a:r>
                      <a:r>
                        <a:rPr lang="de-DE" sz="1000" b="1" u="none" strike="noStrike">
                          <a:effectLst/>
                          <a:latin typeface="Symbol" panose="05050102010706020507" pitchFamily="18" charset="2"/>
                        </a:rPr>
                        <a:t>DD</a:t>
                      </a:r>
                      <a:r>
                        <a:rPr lang="de-DE" sz="1000" b="1" u="none" strike="noStrike">
                          <a:effectLst/>
                        </a:rPr>
                        <a:t>Ct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miR-143</a:t>
                      </a:r>
                      <a:r>
                        <a:rPr lang="de-DE" sz="1000" b="1" u="none" strike="noStrike">
                          <a:effectLst/>
                          <a:latin typeface="Symbol" panose="05050102010706020507" pitchFamily="18" charset="2"/>
                        </a:rPr>
                        <a:t>DD</a:t>
                      </a:r>
                      <a:r>
                        <a:rPr lang="de-DE" sz="1000" b="1" u="none" strike="noStrike">
                          <a:effectLst/>
                        </a:rPr>
                        <a:t>Ct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miR-145</a:t>
                      </a:r>
                      <a:r>
                        <a:rPr lang="de-DE" sz="1000" b="1" u="none" strike="noStrike">
                          <a:effectLst/>
                          <a:latin typeface="Symbol" panose="05050102010706020507" pitchFamily="18" charset="2"/>
                        </a:rPr>
                        <a:t>DD</a:t>
                      </a:r>
                      <a:r>
                        <a:rPr lang="de-DE" sz="1000" b="1" u="none" strike="noStrike">
                          <a:effectLst/>
                        </a:rPr>
                        <a:t>Ct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miR-138fold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miR-181fold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miR-143fold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miR-145fold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27350713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Healthy01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4,59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00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8,19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4,05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24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1,38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85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1,37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84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60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81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59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43681439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Healthy02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3,94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44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8,20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4,50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41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94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85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92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3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9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80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89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8067865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Healthy03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3,41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4,39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8,3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4,39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9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01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69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1,03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91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49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61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0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5149784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Healthy04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4,34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3,14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9,21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6,57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00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23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15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14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00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17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89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45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507741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Healthy05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4,7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5,50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0,75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6,91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42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12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48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74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2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30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35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37653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Healthy06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5,32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4,85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8,18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3,92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96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47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87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1,50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51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3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8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83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0671848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Healthy07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6,1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71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7,6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7,28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77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66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1,42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85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29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5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68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27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98097224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Healthy08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4,76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55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9,87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3,85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41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83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82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1,57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75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77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56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98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8071475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Healthy09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4,66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06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7,8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3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1,31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94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41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80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49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51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18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20157099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Healthy10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4,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3,63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0,28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6,19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15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25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2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76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11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8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42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58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413578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Healthy11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2,92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3,35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9,62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5,25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1,42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03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57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17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68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02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67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13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3162722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Healthy12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3,16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3,93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8,32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4,35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1,19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55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72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1,07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28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68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65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1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7954535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0315915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Enchon01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4,14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3,61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7,11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5,21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20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23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1,93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21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15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8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3,82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16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21915131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Enchon02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4,82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5,8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8,7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4,4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4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45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30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99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72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18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23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98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29869662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Enchon03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3,74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97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7,50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2,85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61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41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1,55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2,57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52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3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93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5,96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15503271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Enchon04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3,21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88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8,64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5,56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1,13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50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41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13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20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41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33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91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3943955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Enchon05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6,98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46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1,15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6,6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6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91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17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16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89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23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44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2471728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Enchon06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5,62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82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9,31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5,41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26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1,56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25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01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41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95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83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0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2751047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61769324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Chondros01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3,9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3,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8,98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5,88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41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08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0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45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33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0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0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7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58581322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Chondros02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4,09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1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7,8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2,6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2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1,26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1,20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2,81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19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40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30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7,01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8301654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Chondros03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3,64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90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7,55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3,66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70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1,48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1,50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1,76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63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79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83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3,40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01153887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Chondros04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3,59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82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6,90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3,46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75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55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2,14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1,96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69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47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4,43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3,90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6309574"/>
                  </a:ext>
                </a:extLst>
              </a:tr>
              <a:tr h="1726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000" b="1" u="none" strike="noStrike">
                          <a:effectLst/>
                        </a:rPr>
                        <a:t>Chondros05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6,02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2,90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0,09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5,73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67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-0,48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04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30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31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1,39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48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000" u="none" strike="noStrike">
                          <a:effectLst/>
                        </a:rPr>
                        <a:t>0,81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809" marR="6809" marT="6809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54543764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5E40DD77-4546-0B1A-1B28-37C3C62792EA}"/>
              </a:ext>
            </a:extLst>
          </p:cNvPr>
          <p:cNvSpPr/>
          <p:nvPr/>
        </p:nvSpPr>
        <p:spPr>
          <a:xfrm>
            <a:off x="396875" y="1166318"/>
            <a:ext cx="11452226" cy="44876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3167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6</Words>
  <Application>Microsoft Office PowerPoint</Application>
  <PresentationFormat>Widescreen</PresentationFormat>
  <Paragraphs>33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</vt:lpstr>
      <vt:lpstr>PowerPoint Presentation</vt:lpstr>
    </vt:vector>
  </TitlesOfParts>
  <Company>UKJ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chrenk, Karin</dc:creator>
  <cp:lastModifiedBy>Karin Schrenk</cp:lastModifiedBy>
  <cp:revision>7</cp:revision>
  <dcterms:created xsi:type="dcterms:W3CDTF">2026-02-17T09:58:21Z</dcterms:created>
  <dcterms:modified xsi:type="dcterms:W3CDTF">2026-04-07T09:13:48Z</dcterms:modified>
</cp:coreProperties>
</file>